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428" r:id="rId2"/>
    <p:sldId id="257" r:id="rId3"/>
  </p:sldIdLst>
  <p:sldSz cx="12192000" cy="6858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19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F9E2A13-FE92-47E6-A4EF-C7AEA4049141}" v="1" dt="2024-06-10T16:58:57.11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754" autoAdjust="0"/>
    <p:restoredTop sz="96046" autoAdjust="0"/>
  </p:normalViewPr>
  <p:slideViewPr>
    <p:cSldViewPr snapToGrid="0">
      <p:cViewPr varScale="1">
        <p:scale>
          <a:sx n="82" d="100"/>
          <a:sy n="82" d="100"/>
        </p:scale>
        <p:origin x="1190" y="72"/>
      </p:cViewPr>
      <p:guideLst>
        <p:guide orient="horz" pos="2319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vier Sierra Isturiz" userId="d8b3d0ae-a242-4736-98fc-9ee2342b4e28" providerId="ADAL" clId="{EF9E2A13-FE92-47E6-A4EF-C7AEA4049141}"/>
    <pc:docChg chg="modSld">
      <pc:chgData name="Javier Sierra Isturiz" userId="d8b3d0ae-a242-4736-98fc-9ee2342b4e28" providerId="ADAL" clId="{EF9E2A13-FE92-47E6-A4EF-C7AEA4049141}" dt="2024-06-10T16:58:57.116" v="0" actId="164"/>
      <pc:docMkLst>
        <pc:docMk/>
      </pc:docMkLst>
      <pc:sldChg chg="addSp modSp">
        <pc:chgData name="Javier Sierra Isturiz" userId="d8b3d0ae-a242-4736-98fc-9ee2342b4e28" providerId="ADAL" clId="{EF9E2A13-FE92-47E6-A4EF-C7AEA4049141}" dt="2024-06-10T16:58:57.116" v="0" actId="164"/>
        <pc:sldMkLst>
          <pc:docMk/>
          <pc:sldMk cId="10123670" sldId="428"/>
        </pc:sldMkLst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7" creationId="{F602A9A3-EB20-40B0-FA30-426EC7690B15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8" creationId="{BA504319-2938-7094-D798-2369408711DD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10" creationId="{B3F01722-CCFE-D9C3-CBBF-0E7BC900D2C1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11" creationId="{99C46614-0821-AEEB-DEAE-889A1D9D4025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12" creationId="{B1EC9EFC-5DDD-E77B-F967-77BEB0320381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15" creationId="{511FF28F-5C11-123D-4D91-A50F5744C09F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16" creationId="{1AE5042E-D5C8-63AE-A506-F428088EEB8D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18" creationId="{D0195B77-5140-7AB5-BAD5-39E1EE80AB73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19" creationId="{BD47E3D5-7EDB-6B5C-ACE8-4018B2CCAFB6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25" creationId="{85887A9C-CEBA-19D9-38CC-739E24F4ADFB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26" creationId="{86C74F70-56FC-333E-E8B0-FC6AFDE039CB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38" creationId="{1FB8F492-5AC1-3B54-C212-75F40D61C5A9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39" creationId="{8CBF13BA-2560-A238-7909-257A1265390C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40" creationId="{45BB3D01-1479-1E2C-5222-6F94DE919C5A}"/>
          </ac:spMkLst>
        </pc:spChg>
        <pc:spChg chg="mod">
          <ac:chgData name="Javier Sierra Isturiz" userId="d8b3d0ae-a242-4736-98fc-9ee2342b4e28" providerId="ADAL" clId="{EF9E2A13-FE92-47E6-A4EF-C7AEA4049141}" dt="2024-06-10T16:58:57.116" v="0" actId="164"/>
          <ac:spMkLst>
            <pc:docMk/>
            <pc:sldMk cId="10123670" sldId="428"/>
            <ac:spMk id="41" creationId="{DDEDD7A8-9557-EAE3-6BAE-B4CD0B57BBF5}"/>
          </ac:spMkLst>
        </pc:spChg>
        <pc:grpChg chg="add mod">
          <ac:chgData name="Javier Sierra Isturiz" userId="d8b3d0ae-a242-4736-98fc-9ee2342b4e28" providerId="ADAL" clId="{EF9E2A13-FE92-47E6-A4EF-C7AEA4049141}" dt="2024-06-10T16:58:57.116" v="0" actId="164"/>
          <ac:grpSpMkLst>
            <pc:docMk/>
            <pc:sldMk cId="10123670" sldId="428"/>
            <ac:grpSpMk id="2" creationId="{DC036AE9-102D-22C0-3706-C3207E493987}"/>
          </ac:grpSpMkLst>
        </pc:grpChg>
        <pc:grpChg chg="mod">
          <ac:chgData name="Javier Sierra Isturiz" userId="d8b3d0ae-a242-4736-98fc-9ee2342b4e28" providerId="ADAL" clId="{EF9E2A13-FE92-47E6-A4EF-C7AEA4049141}" dt="2024-06-10T16:58:57.116" v="0" actId="164"/>
          <ac:grpSpMkLst>
            <pc:docMk/>
            <pc:sldMk cId="10123670" sldId="428"/>
            <ac:grpSpMk id="21" creationId="{F6CAED9A-5ED5-D5AB-7495-324073254140}"/>
          </ac:grpSpMkLst>
        </pc:grpChg>
        <pc:picChg chg="mod">
          <ac:chgData name="Javier Sierra Isturiz" userId="d8b3d0ae-a242-4736-98fc-9ee2342b4e28" providerId="ADAL" clId="{EF9E2A13-FE92-47E6-A4EF-C7AEA4049141}" dt="2024-06-10T16:58:57.116" v="0" actId="164"/>
          <ac:picMkLst>
            <pc:docMk/>
            <pc:sldMk cId="10123670" sldId="428"/>
            <ac:picMk id="3" creationId="{870D612C-EDEF-0BFB-8284-721B91241568}"/>
          </ac:picMkLst>
        </pc:picChg>
        <pc:picChg chg="mod">
          <ac:chgData name="Javier Sierra Isturiz" userId="d8b3d0ae-a242-4736-98fc-9ee2342b4e28" providerId="ADAL" clId="{EF9E2A13-FE92-47E6-A4EF-C7AEA4049141}" dt="2024-06-10T16:58:57.116" v="0" actId="164"/>
          <ac:picMkLst>
            <pc:docMk/>
            <pc:sldMk cId="10123670" sldId="428"/>
            <ac:picMk id="17" creationId="{AA40817F-F42B-A338-C76A-7AECF66F5C83}"/>
          </ac:picMkLst>
        </pc:picChg>
        <pc:picChg chg="mod">
          <ac:chgData name="Javier Sierra Isturiz" userId="d8b3d0ae-a242-4736-98fc-9ee2342b4e28" providerId="ADAL" clId="{EF9E2A13-FE92-47E6-A4EF-C7AEA4049141}" dt="2024-06-10T16:58:57.116" v="0" actId="164"/>
          <ac:picMkLst>
            <pc:docMk/>
            <pc:sldMk cId="10123670" sldId="428"/>
            <ac:picMk id="24" creationId="{C5624542-573C-9B4B-4500-B546FB950E78}"/>
          </ac:picMkLst>
        </pc:picChg>
        <pc:picChg chg="mod">
          <ac:chgData name="Javier Sierra Isturiz" userId="d8b3d0ae-a242-4736-98fc-9ee2342b4e28" providerId="ADAL" clId="{EF9E2A13-FE92-47E6-A4EF-C7AEA4049141}" dt="2024-06-10T16:58:57.116" v="0" actId="164"/>
          <ac:picMkLst>
            <pc:docMk/>
            <pc:sldMk cId="10123670" sldId="428"/>
            <ac:picMk id="27" creationId="{24D298D5-F206-65D9-EB31-5F9A35774AC5}"/>
          </ac:picMkLst>
        </pc:picChg>
        <pc:picChg chg="mod">
          <ac:chgData name="Javier Sierra Isturiz" userId="d8b3d0ae-a242-4736-98fc-9ee2342b4e28" providerId="ADAL" clId="{EF9E2A13-FE92-47E6-A4EF-C7AEA4049141}" dt="2024-06-10T16:58:57.116" v="0" actId="164"/>
          <ac:picMkLst>
            <pc:docMk/>
            <pc:sldMk cId="10123670" sldId="428"/>
            <ac:picMk id="34" creationId="{61878702-9A67-53EE-FDD0-5EB20C6B9B58}"/>
          </ac:picMkLst>
        </pc:picChg>
        <pc:picChg chg="mod">
          <ac:chgData name="Javier Sierra Isturiz" userId="d8b3d0ae-a242-4736-98fc-9ee2342b4e28" providerId="ADAL" clId="{EF9E2A13-FE92-47E6-A4EF-C7AEA4049141}" dt="2024-06-10T16:58:57.116" v="0" actId="164"/>
          <ac:picMkLst>
            <pc:docMk/>
            <pc:sldMk cId="10123670" sldId="428"/>
            <ac:picMk id="49" creationId="{84A32998-15B6-5D74-6D56-B719C8765CD2}"/>
          </ac:picMkLst>
        </pc:picChg>
        <pc:cxnChg chg="mod">
          <ac:chgData name="Javier Sierra Isturiz" userId="d8b3d0ae-a242-4736-98fc-9ee2342b4e28" providerId="ADAL" clId="{EF9E2A13-FE92-47E6-A4EF-C7AEA4049141}" dt="2024-06-10T16:58:57.116" v="0" actId="164"/>
          <ac:cxnSpMkLst>
            <pc:docMk/>
            <pc:sldMk cId="10123670" sldId="428"/>
            <ac:cxnSpMk id="31" creationId="{52246E40-391E-B242-7542-8C9A2E8CC30B}"/>
          </ac:cxnSpMkLst>
        </pc:cxnChg>
        <pc:cxnChg chg="mod">
          <ac:chgData name="Javier Sierra Isturiz" userId="d8b3d0ae-a242-4736-98fc-9ee2342b4e28" providerId="ADAL" clId="{EF9E2A13-FE92-47E6-A4EF-C7AEA4049141}" dt="2024-06-10T16:58:57.116" v="0" actId="164"/>
          <ac:cxnSpMkLst>
            <pc:docMk/>
            <pc:sldMk cId="10123670" sldId="428"/>
            <ac:cxnSpMk id="32" creationId="{237C4AA6-4A05-EB0A-AF09-80033EA6C2CF}"/>
          </ac:cxnSpMkLst>
        </pc:cxnChg>
        <pc:cxnChg chg="mod">
          <ac:chgData name="Javier Sierra Isturiz" userId="d8b3d0ae-a242-4736-98fc-9ee2342b4e28" providerId="ADAL" clId="{EF9E2A13-FE92-47E6-A4EF-C7AEA4049141}" dt="2024-06-10T16:58:57.116" v="0" actId="164"/>
          <ac:cxnSpMkLst>
            <pc:docMk/>
            <pc:sldMk cId="10123670" sldId="428"/>
            <ac:cxnSpMk id="37" creationId="{164EC859-AE72-1CB1-927A-6C241132744A}"/>
          </ac:cxnSpMkLst>
        </pc:cxnChg>
        <pc:cxnChg chg="mod">
          <ac:chgData name="Javier Sierra Isturiz" userId="d8b3d0ae-a242-4736-98fc-9ee2342b4e28" providerId="ADAL" clId="{EF9E2A13-FE92-47E6-A4EF-C7AEA4049141}" dt="2024-06-10T16:58:57.116" v="0" actId="164"/>
          <ac:cxnSpMkLst>
            <pc:docMk/>
            <pc:sldMk cId="10123670" sldId="428"/>
            <ac:cxnSpMk id="42" creationId="{57222D1C-322F-1C4F-0D59-E53CB5FFD744}"/>
          </ac:cxnSpMkLst>
        </pc:cxnChg>
        <pc:cxnChg chg="mod">
          <ac:chgData name="Javier Sierra Isturiz" userId="d8b3d0ae-a242-4736-98fc-9ee2342b4e28" providerId="ADAL" clId="{EF9E2A13-FE92-47E6-A4EF-C7AEA4049141}" dt="2024-06-10T16:58:57.116" v="0" actId="164"/>
          <ac:cxnSpMkLst>
            <pc:docMk/>
            <pc:sldMk cId="10123670" sldId="428"/>
            <ac:cxnSpMk id="43" creationId="{A40C9BFA-77B3-566B-920D-F1C86FFFE635}"/>
          </ac:cxnSpMkLst>
        </pc:cxnChg>
        <pc:cxnChg chg="mod">
          <ac:chgData name="Javier Sierra Isturiz" userId="d8b3d0ae-a242-4736-98fc-9ee2342b4e28" providerId="ADAL" clId="{EF9E2A13-FE92-47E6-A4EF-C7AEA4049141}" dt="2024-06-10T16:58:57.116" v="0" actId="164"/>
          <ac:cxnSpMkLst>
            <pc:docMk/>
            <pc:sldMk cId="10123670" sldId="428"/>
            <ac:cxnSpMk id="45" creationId="{2E397CCC-292E-0A9D-24EA-BF2B63D3A710}"/>
          </ac:cxnSpMkLst>
        </pc:cxnChg>
        <pc:cxnChg chg="mod">
          <ac:chgData name="Javier Sierra Isturiz" userId="d8b3d0ae-a242-4736-98fc-9ee2342b4e28" providerId="ADAL" clId="{EF9E2A13-FE92-47E6-A4EF-C7AEA4049141}" dt="2024-06-10T16:58:57.116" v="0" actId="164"/>
          <ac:cxnSpMkLst>
            <pc:docMk/>
            <pc:sldMk cId="10123670" sldId="428"/>
            <ac:cxnSpMk id="46" creationId="{96BCFC22-39E4-45B5-0F06-C6B65FE5B357}"/>
          </ac:cxnSpMkLst>
        </pc:cxnChg>
        <pc:cxnChg chg="mod">
          <ac:chgData name="Javier Sierra Isturiz" userId="d8b3d0ae-a242-4736-98fc-9ee2342b4e28" providerId="ADAL" clId="{EF9E2A13-FE92-47E6-A4EF-C7AEA4049141}" dt="2024-06-10T16:58:57.116" v="0" actId="164"/>
          <ac:cxnSpMkLst>
            <pc:docMk/>
            <pc:sldMk cId="10123670" sldId="428"/>
            <ac:cxnSpMk id="47" creationId="{475C03C9-CC09-0B2B-6A91-32998E9D5C37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EEA600-4D68-4B5C-8A9C-7D44C8E7A2B5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4D8F4E-D33F-4527-A557-AB599328E1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98646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D05117-33A7-4749-B557-4AE1BE2AFA1F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7845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36C5D-8817-4A81-93DC-2A1C0B43B363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00A99-E0C5-485F-B4D1-BA280DDA1F0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9810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36C5D-8817-4A81-93DC-2A1C0B43B363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00A99-E0C5-485F-B4D1-BA280DDA1F0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6391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36C5D-8817-4A81-93DC-2A1C0B43B363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00A99-E0C5-485F-B4D1-BA280DDA1F0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36792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36C5D-8817-4A81-93DC-2A1C0B43B363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00A99-E0C5-485F-B4D1-BA280DDA1F0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6307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36C5D-8817-4A81-93DC-2A1C0B43B363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00A99-E0C5-485F-B4D1-BA280DDA1F0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852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36C5D-8817-4A81-93DC-2A1C0B43B363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00A99-E0C5-485F-B4D1-BA280DDA1F0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3581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36C5D-8817-4A81-93DC-2A1C0B43B363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00A99-E0C5-485F-B4D1-BA280DDA1F0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0199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36C5D-8817-4A81-93DC-2A1C0B43B363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00A99-E0C5-485F-B4D1-BA280DDA1F0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0529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36C5D-8817-4A81-93DC-2A1C0B43B363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00A99-E0C5-485F-B4D1-BA280DDA1F0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541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36C5D-8817-4A81-93DC-2A1C0B43B363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00A99-E0C5-485F-B4D1-BA280DDA1F0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3198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36C5D-8817-4A81-93DC-2A1C0B43B363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00A99-E0C5-485F-B4D1-BA280DDA1F0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1426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936C5D-8817-4A81-93DC-2A1C0B43B363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00A99-E0C5-485F-B4D1-BA280DDA1F0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7473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10" Type="http://schemas.openxmlformats.org/officeDocument/2006/relationships/image" Target="../media/image8.jpeg"/><Relationship Id="rId4" Type="http://schemas.openxmlformats.org/officeDocument/2006/relationships/image" Target="../media/image2.jpg"/><Relationship Id="rId9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DC036AE9-102D-22C0-3706-C3207E493987}"/>
              </a:ext>
            </a:extLst>
          </p:cNvPr>
          <p:cNvGrpSpPr/>
          <p:nvPr/>
        </p:nvGrpSpPr>
        <p:grpSpPr>
          <a:xfrm>
            <a:off x="223701" y="536059"/>
            <a:ext cx="11797702" cy="5920849"/>
            <a:chOff x="223701" y="536059"/>
            <a:chExt cx="11797702" cy="5920849"/>
          </a:xfrm>
        </p:grpSpPr>
        <p:pic>
          <p:nvPicPr>
            <p:cNvPr id="24" name="Imagen 23" descr="Dibujo de una persona&#10;&#10;Descripción generada automáticamente con confianza baja">
              <a:extLst>
                <a:ext uri="{FF2B5EF4-FFF2-40B4-BE49-F238E27FC236}">
                  <a16:creationId xmlns:a16="http://schemas.microsoft.com/office/drawing/2014/main" id="{C5624542-573C-9B4B-4500-B546FB950E7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4809" y="3452856"/>
              <a:ext cx="2880000" cy="2880000"/>
            </a:xfrm>
            <a:prstGeom prst="rect">
              <a:avLst/>
            </a:prstGeom>
          </p:spPr>
        </p:pic>
        <p:pic>
          <p:nvPicPr>
            <p:cNvPr id="3" name="Imagen 2" descr="Imagen que contiene interior, teclado, computadora, computer&#10;&#10;Descripción generada automáticamente">
              <a:extLst>
                <a:ext uri="{FF2B5EF4-FFF2-40B4-BE49-F238E27FC236}">
                  <a16:creationId xmlns:a16="http://schemas.microsoft.com/office/drawing/2014/main" id="{870D612C-EDEF-0BFB-8284-721B9124156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40098" y="542763"/>
              <a:ext cx="2880000" cy="2880000"/>
            </a:xfrm>
            <a:prstGeom prst="rect">
              <a:avLst/>
            </a:prstGeom>
          </p:spPr>
        </p:pic>
        <p:pic>
          <p:nvPicPr>
            <p:cNvPr id="49" name="Imagen 48" descr="Patrón de fondo&#10;&#10;Descripción generada automáticamente">
              <a:extLst>
                <a:ext uri="{FF2B5EF4-FFF2-40B4-BE49-F238E27FC236}">
                  <a16:creationId xmlns:a16="http://schemas.microsoft.com/office/drawing/2014/main" id="{84A32998-15B6-5D74-6D56-B719C8765CD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21134" y="542763"/>
              <a:ext cx="2880000" cy="2880000"/>
            </a:xfrm>
            <a:prstGeom prst="rect">
              <a:avLst/>
            </a:prstGeom>
          </p:spPr>
        </p:pic>
        <p:pic>
          <p:nvPicPr>
            <p:cNvPr id="34" name="Imagen 33" descr="Imagen que contiene interior, computadora, morado, computer&#10;&#10;Descripción generada automáticamente">
              <a:extLst>
                <a:ext uri="{FF2B5EF4-FFF2-40B4-BE49-F238E27FC236}">
                  <a16:creationId xmlns:a16="http://schemas.microsoft.com/office/drawing/2014/main" id="{61878702-9A67-53EE-FDD0-5EB20C6B9B5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02170" y="542763"/>
              <a:ext cx="2880000" cy="2880000"/>
            </a:xfrm>
            <a:prstGeom prst="rect">
              <a:avLst/>
            </a:prstGeom>
          </p:spPr>
        </p:pic>
        <p:pic>
          <p:nvPicPr>
            <p:cNvPr id="17" name="Imagen 16" descr="Teclado de computadora iluminado&#10;&#10;Descripción generada automáticamente con confianza baja">
              <a:extLst>
                <a:ext uri="{FF2B5EF4-FFF2-40B4-BE49-F238E27FC236}">
                  <a16:creationId xmlns:a16="http://schemas.microsoft.com/office/drawing/2014/main" id="{AA40817F-F42B-A338-C76A-7AECF66F5C8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7205" y="542763"/>
              <a:ext cx="2880000" cy="2880000"/>
            </a:xfrm>
            <a:prstGeom prst="rect">
              <a:avLst/>
            </a:prstGeom>
          </p:spPr>
        </p:pic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1AE5042E-D5C8-63AE-A506-F428088EEB8D}"/>
                </a:ext>
              </a:extLst>
            </p:cNvPr>
            <p:cNvSpPr txBox="1"/>
            <p:nvPr/>
          </p:nvSpPr>
          <p:spPr>
            <a:xfrm>
              <a:off x="6794872" y="6087576"/>
              <a:ext cx="15121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>
                  <a:solidFill>
                    <a:schemeClr val="bg1"/>
                  </a:solidFill>
                </a:rPr>
                <a:t>AAAA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F602A9A3-EB20-40B0-FA30-426EC7690B15}"/>
                </a:ext>
              </a:extLst>
            </p:cNvPr>
            <p:cNvSpPr txBox="1"/>
            <p:nvPr/>
          </p:nvSpPr>
          <p:spPr>
            <a:xfrm>
              <a:off x="223701" y="541292"/>
              <a:ext cx="50129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BA504319-2938-7094-D798-2369408711DD}"/>
                </a:ext>
              </a:extLst>
            </p:cNvPr>
            <p:cNvSpPr txBox="1"/>
            <p:nvPr/>
          </p:nvSpPr>
          <p:spPr>
            <a:xfrm>
              <a:off x="3177033" y="536059"/>
              <a:ext cx="55029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’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B3F01722-CCFE-D9C3-CBBF-0E7BC900D2C1}"/>
                </a:ext>
              </a:extLst>
            </p:cNvPr>
            <p:cNvSpPr txBox="1"/>
            <p:nvPr/>
          </p:nvSpPr>
          <p:spPr>
            <a:xfrm>
              <a:off x="255244" y="3092578"/>
              <a:ext cx="28181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99C46614-0821-AEEB-DEAE-889A1D9D4025}"/>
                </a:ext>
              </a:extLst>
            </p:cNvPr>
            <p:cNvSpPr txBox="1"/>
            <p:nvPr/>
          </p:nvSpPr>
          <p:spPr>
            <a:xfrm>
              <a:off x="3193030" y="3090912"/>
              <a:ext cx="28181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X2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B1EC9EFC-5DDD-E77B-F967-77BEB0320381}"/>
                </a:ext>
              </a:extLst>
            </p:cNvPr>
            <p:cNvSpPr txBox="1"/>
            <p:nvPr/>
          </p:nvSpPr>
          <p:spPr>
            <a:xfrm>
              <a:off x="2722022" y="544807"/>
              <a:ext cx="6450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2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511FF28F-5C11-123D-4D91-A50F5744C09F}"/>
                </a:ext>
              </a:extLst>
            </p:cNvPr>
            <p:cNvSpPr txBox="1"/>
            <p:nvPr/>
          </p:nvSpPr>
          <p:spPr>
            <a:xfrm>
              <a:off x="6104398" y="3100942"/>
              <a:ext cx="28181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D0195B77-5140-7AB5-BAD5-39E1EE80AB73}"/>
                </a:ext>
              </a:extLst>
            </p:cNvPr>
            <p:cNvSpPr txBox="1"/>
            <p:nvPr/>
          </p:nvSpPr>
          <p:spPr>
            <a:xfrm>
              <a:off x="9042184" y="3091656"/>
              <a:ext cx="28181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X2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BD47E3D5-7EDB-6B5C-ACE8-4018B2CCAFB6}"/>
                </a:ext>
              </a:extLst>
            </p:cNvPr>
            <p:cNvSpPr txBox="1"/>
            <p:nvPr/>
          </p:nvSpPr>
          <p:spPr>
            <a:xfrm>
              <a:off x="6050723" y="541292"/>
              <a:ext cx="50129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85887A9C-CEBA-19D9-38CC-739E24F4ADFB}"/>
                </a:ext>
              </a:extLst>
            </p:cNvPr>
            <p:cNvSpPr txBox="1"/>
            <p:nvPr/>
          </p:nvSpPr>
          <p:spPr>
            <a:xfrm>
              <a:off x="9004055" y="536059"/>
              <a:ext cx="55029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’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86C74F70-56FC-333E-E8B0-FC6AFDE039CB}"/>
                </a:ext>
              </a:extLst>
            </p:cNvPr>
            <p:cNvSpPr txBox="1"/>
            <p:nvPr/>
          </p:nvSpPr>
          <p:spPr>
            <a:xfrm>
              <a:off x="8549044" y="544807"/>
              <a:ext cx="6450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4</a:t>
              </a:r>
            </a:p>
          </p:txBody>
        </p:sp>
        <p:pic>
          <p:nvPicPr>
            <p:cNvPr id="27" name="Imagen 26" descr="Imagen que contiene interior, teclado, computadora, monitor&#10;&#10;Descripción generada automáticamente">
              <a:extLst>
                <a:ext uri="{FF2B5EF4-FFF2-40B4-BE49-F238E27FC236}">
                  <a16:creationId xmlns:a16="http://schemas.microsoft.com/office/drawing/2014/main" id="{24D298D5-F206-65D9-EB31-5F9A35774AC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02170" y="3452856"/>
              <a:ext cx="2880000" cy="2880000"/>
            </a:xfrm>
            <a:prstGeom prst="rect">
              <a:avLst/>
            </a:prstGeom>
          </p:spPr>
        </p:pic>
        <p:cxnSp>
          <p:nvCxnSpPr>
            <p:cNvPr id="37" name="Conector recto de flecha 36">
              <a:extLst>
                <a:ext uri="{FF2B5EF4-FFF2-40B4-BE49-F238E27FC236}">
                  <a16:creationId xmlns:a16="http://schemas.microsoft.com/office/drawing/2014/main" id="{164EC859-AE72-1CB1-927A-6C241132744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03918" y="1248184"/>
              <a:ext cx="119118" cy="83729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1FB8F492-5AC1-3B54-C212-75F40D61C5A9}"/>
                </a:ext>
              </a:extLst>
            </p:cNvPr>
            <p:cNvSpPr txBox="1"/>
            <p:nvPr/>
          </p:nvSpPr>
          <p:spPr>
            <a:xfrm>
              <a:off x="223701" y="3443016"/>
              <a:ext cx="50129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8CBF13BA-2560-A238-7909-257A1265390C}"/>
                </a:ext>
              </a:extLst>
            </p:cNvPr>
            <p:cNvSpPr txBox="1"/>
            <p:nvPr/>
          </p:nvSpPr>
          <p:spPr>
            <a:xfrm>
              <a:off x="3177033" y="3437783"/>
              <a:ext cx="55029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’</a:t>
              </a:r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45BB3D01-1479-1E2C-5222-6F94DE919C5A}"/>
                </a:ext>
              </a:extLst>
            </p:cNvPr>
            <p:cNvSpPr txBox="1"/>
            <p:nvPr/>
          </p:nvSpPr>
          <p:spPr>
            <a:xfrm>
              <a:off x="255244" y="5994302"/>
              <a:ext cx="28181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id="{DDEDD7A8-9557-EAE3-6BAE-B4CD0B57BBF5}"/>
                </a:ext>
              </a:extLst>
            </p:cNvPr>
            <p:cNvSpPr txBox="1"/>
            <p:nvPr/>
          </p:nvSpPr>
          <p:spPr>
            <a:xfrm>
              <a:off x="2722022" y="3446531"/>
              <a:ext cx="6450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6</a:t>
              </a:r>
            </a:p>
          </p:txBody>
        </p:sp>
        <p:cxnSp>
          <p:nvCxnSpPr>
            <p:cNvPr id="42" name="Conector recto de flecha 41">
              <a:extLst>
                <a:ext uri="{FF2B5EF4-FFF2-40B4-BE49-F238E27FC236}">
                  <a16:creationId xmlns:a16="http://schemas.microsoft.com/office/drawing/2014/main" id="{57222D1C-322F-1C4F-0D59-E53CB5FFD74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49838" y="1794660"/>
              <a:ext cx="119118" cy="83729"/>
            </a:xfrm>
            <a:prstGeom prst="straightConnector1">
              <a:avLst/>
            </a:prstGeom>
            <a:ln w="3810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ector recto de flecha 42">
              <a:extLst>
                <a:ext uri="{FF2B5EF4-FFF2-40B4-BE49-F238E27FC236}">
                  <a16:creationId xmlns:a16="http://schemas.microsoft.com/office/drawing/2014/main" id="{A40C9BFA-77B3-566B-920D-F1C86FFFE63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57078" y="2675664"/>
              <a:ext cx="119118" cy="83729"/>
            </a:xfrm>
            <a:prstGeom prst="straightConnector1">
              <a:avLst/>
            </a:prstGeom>
            <a:ln w="3810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ector recto de flecha 44">
              <a:extLst>
                <a:ext uri="{FF2B5EF4-FFF2-40B4-BE49-F238E27FC236}">
                  <a16:creationId xmlns:a16="http://schemas.microsoft.com/office/drawing/2014/main" id="{2E397CCC-292E-0A9D-24EA-BF2B63D3A71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96242" y="1242277"/>
              <a:ext cx="119118" cy="83729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ector recto de flecha 45">
              <a:extLst>
                <a:ext uri="{FF2B5EF4-FFF2-40B4-BE49-F238E27FC236}">
                  <a16:creationId xmlns:a16="http://schemas.microsoft.com/office/drawing/2014/main" id="{96BCFC22-39E4-45B5-0F06-C6B65FE5B35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42162" y="1788753"/>
              <a:ext cx="119118" cy="83729"/>
            </a:xfrm>
            <a:prstGeom prst="straightConnector1">
              <a:avLst/>
            </a:prstGeom>
            <a:ln w="3810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ector recto de flecha 46">
              <a:extLst>
                <a:ext uri="{FF2B5EF4-FFF2-40B4-BE49-F238E27FC236}">
                  <a16:creationId xmlns:a16="http://schemas.microsoft.com/office/drawing/2014/main" id="{475C03C9-CC09-0B2B-6A91-32998E9D5C3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49402" y="2669757"/>
              <a:ext cx="119118" cy="83729"/>
            </a:xfrm>
            <a:prstGeom prst="straightConnector1">
              <a:avLst/>
            </a:prstGeom>
            <a:ln w="3810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ector recto de flecha 30">
              <a:extLst>
                <a:ext uri="{FF2B5EF4-FFF2-40B4-BE49-F238E27FC236}">
                  <a16:creationId xmlns:a16="http://schemas.microsoft.com/office/drawing/2014/main" id="{52246E40-391E-B242-7542-8C9A2E8CC30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94038" y="1586048"/>
              <a:ext cx="119118" cy="83729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ector recto de flecha 31">
              <a:extLst>
                <a:ext uri="{FF2B5EF4-FFF2-40B4-BE49-F238E27FC236}">
                  <a16:creationId xmlns:a16="http://schemas.microsoft.com/office/drawing/2014/main" id="{237C4AA6-4A05-EB0A-AF09-80033EA6C2C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6362" y="1580141"/>
              <a:ext cx="119118" cy="83729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Grupo 20">
              <a:extLst>
                <a:ext uri="{FF2B5EF4-FFF2-40B4-BE49-F238E27FC236}">
                  <a16:creationId xmlns:a16="http://schemas.microsoft.com/office/drawing/2014/main" id="{F6CAED9A-5ED5-D5AB-7495-324073254140}"/>
                </a:ext>
              </a:extLst>
            </p:cNvPr>
            <p:cNvGrpSpPr/>
            <p:nvPr/>
          </p:nvGrpSpPr>
          <p:grpSpPr>
            <a:xfrm>
              <a:off x="6083151" y="3473149"/>
              <a:ext cx="5938252" cy="2774132"/>
              <a:chOff x="6083151" y="3473149"/>
              <a:chExt cx="5938252" cy="2774132"/>
            </a:xfrm>
          </p:grpSpPr>
          <p:grpSp>
            <p:nvGrpSpPr>
              <p:cNvPr id="9" name="Grupo 8">
                <a:extLst>
                  <a:ext uri="{FF2B5EF4-FFF2-40B4-BE49-F238E27FC236}">
                    <a16:creationId xmlns:a16="http://schemas.microsoft.com/office/drawing/2014/main" id="{19F924A4-5D21-5B75-3A6E-53C2C140EB69}"/>
                  </a:ext>
                </a:extLst>
              </p:cNvPr>
              <p:cNvGrpSpPr/>
              <p:nvPr/>
            </p:nvGrpSpPr>
            <p:grpSpPr>
              <a:xfrm>
                <a:off x="8942709" y="3508628"/>
                <a:ext cx="3078694" cy="2726951"/>
                <a:chOff x="8942709" y="3508628"/>
                <a:chExt cx="3078694" cy="2726951"/>
              </a:xfrm>
            </p:grpSpPr>
            <p:pic>
              <p:nvPicPr>
                <p:cNvPr id="5" name="Imagen 4" descr="Gráfico, Histograma&#10;&#10;Descripción generada automáticamente">
                  <a:extLst>
                    <a:ext uri="{FF2B5EF4-FFF2-40B4-BE49-F238E27FC236}">
                      <a16:creationId xmlns:a16="http://schemas.microsoft.com/office/drawing/2014/main" id="{15ED29B1-DBA6-13EB-CBCF-F8566692664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982235" y="4075579"/>
                  <a:ext cx="3039168" cy="2160000"/>
                </a:xfrm>
                <a:prstGeom prst="rect">
                  <a:avLst/>
                </a:prstGeom>
              </p:spPr>
            </p:pic>
            <p:sp>
              <p:nvSpPr>
                <p:cNvPr id="6" name="Cuadro de texto 2">
                  <a:extLst>
                    <a:ext uri="{FF2B5EF4-FFF2-40B4-BE49-F238E27FC236}">
                      <a16:creationId xmlns:a16="http://schemas.microsoft.com/office/drawing/2014/main" id="{C1915328-7867-4898-1DB8-C00ACA29308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8942709" y="3508628"/>
                  <a:ext cx="435706" cy="35721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1600" b="1" dirty="0">
                      <a:latin typeface="Arial" panose="020B060402020202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E</a:t>
                  </a:r>
                  <a:endParaRPr lang="es-ES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0" name="Grupo 19">
                <a:extLst>
                  <a:ext uri="{FF2B5EF4-FFF2-40B4-BE49-F238E27FC236}">
                    <a16:creationId xmlns:a16="http://schemas.microsoft.com/office/drawing/2014/main" id="{8F5D2E83-A6EF-019A-53E9-2A85BAFA4F7E}"/>
                  </a:ext>
                </a:extLst>
              </p:cNvPr>
              <p:cNvGrpSpPr/>
              <p:nvPr/>
            </p:nvGrpSpPr>
            <p:grpSpPr>
              <a:xfrm>
                <a:off x="6083151" y="3473149"/>
                <a:ext cx="3024000" cy="2774132"/>
                <a:chOff x="6083151" y="3473149"/>
                <a:chExt cx="3024000" cy="2774132"/>
              </a:xfrm>
            </p:grpSpPr>
            <p:pic>
              <p:nvPicPr>
                <p:cNvPr id="13" name="Imagen 12" descr="Gráfico&#10;&#10;Descripción generada automáticamente">
                  <a:extLst>
                    <a:ext uri="{FF2B5EF4-FFF2-40B4-BE49-F238E27FC236}">
                      <a16:creationId xmlns:a16="http://schemas.microsoft.com/office/drawing/2014/main" id="{A43BB6B3-8E1B-771F-2192-8E52702BA68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083151" y="4039579"/>
                  <a:ext cx="3024000" cy="2207702"/>
                </a:xfrm>
                <a:prstGeom prst="rect">
                  <a:avLst/>
                </a:prstGeom>
              </p:spPr>
            </p:pic>
            <p:sp>
              <p:nvSpPr>
                <p:cNvPr id="14" name="Cuadro de texto 2">
                  <a:extLst>
                    <a:ext uri="{FF2B5EF4-FFF2-40B4-BE49-F238E27FC236}">
                      <a16:creationId xmlns:a16="http://schemas.microsoft.com/office/drawing/2014/main" id="{CB25A4B6-889C-A5FC-5A3E-CBEF63EB32D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096000" y="3473149"/>
                  <a:ext cx="426233" cy="35721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1600" b="1" dirty="0">
                      <a:latin typeface="Arial" panose="020B060402020202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D</a:t>
                  </a:r>
                  <a:endParaRPr lang="es-ES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01236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78A78A31-EEF7-C9CD-9380-4A770D6B5B50}"/>
              </a:ext>
            </a:extLst>
          </p:cNvPr>
          <p:cNvSpPr txBox="1"/>
          <p:nvPr/>
        </p:nvSpPr>
        <p:spPr>
          <a:xfrm>
            <a:off x="502154" y="1290858"/>
            <a:ext cx="10543798" cy="1924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1422"/>
              </a:spcAft>
            </a:pP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: NEUROD1-hmOEG does not transition to a neural stem cell-like state before differentiating into </a:t>
            </a:r>
            <a:r>
              <a:rPr lang="en-US" sz="16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s.</a:t>
            </a: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ages of SOX2 (white) and KI67 (red) expression at 2, 4 and 6 dpi. Arrows indicate cells that express Ki67: yellow arrows point GFP+ cells (cells expressing NEUROD1-GFP construct) and white arrows point uninfected cells.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histograms (D, E) represent the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an±SD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the percentage of GFP+ cells expressing KI67 or SOX2 over the total of GFP+ cells (triplicates). Statistical tests applied were Two-way ANOVA and post-hoc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ukey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est (****p≤0.0001,**p≤0.01) for multiple comparisons between means (n=3 independent experiments, 10 fields were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sed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r>
              <a:rPr lang="es-E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ale bar: 50 µm. DPI: days post-infection.</a:t>
            </a: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394103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75</TotalTime>
  <Words>180</Words>
  <Application>Microsoft Office PowerPoint</Application>
  <PresentationFormat>Panorámica</PresentationFormat>
  <Paragraphs>19</Paragraphs>
  <Slides>2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Sierra Isturiz</dc:creator>
  <cp:lastModifiedBy>Javier Sierra Isturiz</cp:lastModifiedBy>
  <cp:revision>30</cp:revision>
  <dcterms:created xsi:type="dcterms:W3CDTF">2023-07-29T12:14:49Z</dcterms:created>
  <dcterms:modified xsi:type="dcterms:W3CDTF">2024-06-10T16:59:02Z</dcterms:modified>
</cp:coreProperties>
</file>